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74" r:id="rId4"/>
    <p:sldId id="263" r:id="rId5"/>
    <p:sldId id="272" r:id="rId6"/>
    <p:sldId id="273" r:id="rId7"/>
    <p:sldId id="276" r:id="rId8"/>
    <p:sldId id="260" r:id="rId9"/>
    <p:sldId id="268" r:id="rId10"/>
    <p:sldId id="267" r:id="rId11"/>
    <p:sldId id="270" r:id="rId12"/>
    <p:sldId id="269" r:id="rId13"/>
    <p:sldId id="271" r:id="rId14"/>
    <p:sldId id="275" r:id="rId1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sley Boyd" initials="LB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265" autoAdjust="0"/>
    <p:restoredTop sz="94660"/>
  </p:normalViewPr>
  <p:slideViewPr>
    <p:cSldViewPr>
      <p:cViewPr>
        <p:scale>
          <a:sx n="100" d="100"/>
          <a:sy n="100" d="100"/>
        </p:scale>
        <p:origin x="-1884" y="18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5164" y="3646278"/>
            <a:ext cx="67045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portion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696 Philippine pigmented rice accessions that fell within eac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eta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. X-axis = the different varietal groups. Y-axis = the proportion of rice samples in each group. Trop1 = japonica typ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5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4" t="5330" r="5511" b="12552"/>
          <a:stretch/>
        </p:blipFill>
        <p:spPr bwMode="auto">
          <a:xfrm>
            <a:off x="211723" y="51536"/>
            <a:ext cx="6587997" cy="3493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8357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6777" y="4687901"/>
            <a:ext cx="6629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hilippine pigmented rice accessions having the 14-bp deletion within the ric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known to result in loss of red pericar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17" y="304800"/>
            <a:ext cx="6766560" cy="40599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423568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96088" y="43785"/>
            <a:ext cx="4125046" cy="7560168"/>
            <a:chOff x="296088" y="43785"/>
            <a:chExt cx="4125046" cy="7560168"/>
          </a:xfrm>
        </p:grpSpPr>
        <p:grpSp>
          <p:nvGrpSpPr>
            <p:cNvPr id="3" name="Group 2"/>
            <p:cNvGrpSpPr/>
            <p:nvPr/>
          </p:nvGrpSpPr>
          <p:grpSpPr>
            <a:xfrm>
              <a:off x="296088" y="43785"/>
              <a:ext cx="4099048" cy="1537292"/>
              <a:chOff x="296088" y="43785"/>
              <a:chExt cx="4099048" cy="1537292"/>
            </a:xfrm>
          </p:grpSpPr>
          <p:pic>
            <p:nvPicPr>
              <p:cNvPr id="2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081" r="54257" b="69068"/>
              <a:stretch/>
            </p:blipFill>
            <p:spPr bwMode="auto">
              <a:xfrm>
                <a:off x="296088" y="333189"/>
                <a:ext cx="4099048" cy="12478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1064365" y="46630"/>
                <a:ext cx="1066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ea</a:t>
                </a:r>
                <a:endPara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933699" y="43785"/>
                <a:ext cx="1066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ngth</a:t>
                </a:r>
                <a:endPara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296088" y="1524897"/>
              <a:ext cx="4125046" cy="6079056"/>
              <a:chOff x="296088" y="1524897"/>
              <a:chExt cx="4125046" cy="6079056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296088" y="2971800"/>
                <a:ext cx="4099048" cy="1575685"/>
                <a:chOff x="296088" y="3149769"/>
                <a:chExt cx="4099048" cy="1575685"/>
              </a:xfrm>
            </p:grpSpPr>
            <p:pic>
              <p:nvPicPr>
                <p:cNvPr id="18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7807" r="54257" b="4582"/>
                <a:stretch/>
              </p:blipFill>
              <p:spPr bwMode="auto">
                <a:xfrm>
                  <a:off x="296088" y="3488323"/>
                  <a:ext cx="4099048" cy="123713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9" name="TextBox 18"/>
                <p:cNvSpPr txBox="1"/>
                <p:nvPr/>
              </p:nvSpPr>
              <p:spPr>
                <a:xfrm>
                  <a:off x="990600" y="3149769"/>
                  <a:ext cx="7620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ue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792505" y="3149769"/>
                  <a:ext cx="11811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aturation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" name="Group 5"/>
              <p:cNvGrpSpPr/>
              <p:nvPr/>
            </p:nvGrpSpPr>
            <p:grpSpPr>
              <a:xfrm>
                <a:off x="506505" y="4547485"/>
                <a:ext cx="3888631" cy="1561995"/>
                <a:chOff x="506505" y="4794948"/>
                <a:chExt cx="3888631" cy="1561995"/>
              </a:xfrm>
            </p:grpSpPr>
            <p:pic>
              <p:nvPicPr>
                <p:cNvPr id="15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142" t="35854" r="9930" b="36987"/>
                <a:stretch/>
              </p:blipFill>
              <p:spPr bwMode="auto">
                <a:xfrm>
                  <a:off x="506505" y="5181600"/>
                  <a:ext cx="3888631" cy="117534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1143000" y="4794948"/>
                  <a:ext cx="7620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3086098" y="4794948"/>
                  <a:ext cx="11049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tensity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447207" y="1524897"/>
                <a:ext cx="3947929" cy="1446903"/>
                <a:chOff x="505159" y="6595646"/>
                <a:chExt cx="4026049" cy="1532653"/>
              </a:xfrm>
            </p:grpSpPr>
            <p:pic>
              <p:nvPicPr>
                <p:cNvPr id="1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142" t="3601" r="9930" b="69748"/>
                <a:stretch/>
              </p:blipFill>
              <p:spPr bwMode="auto">
                <a:xfrm>
                  <a:off x="505159" y="6934200"/>
                  <a:ext cx="4026049" cy="11940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3" name="TextBox 12"/>
                <p:cNvSpPr txBox="1"/>
                <p:nvPr/>
              </p:nvSpPr>
              <p:spPr>
                <a:xfrm>
                  <a:off x="971549" y="6595646"/>
                  <a:ext cx="11049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idth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933700" y="6595646"/>
                  <a:ext cx="12573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oundness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296088" y="6019800"/>
                <a:ext cx="4125046" cy="1584153"/>
                <a:chOff x="270090" y="1554481"/>
                <a:chExt cx="4125046" cy="1584153"/>
              </a:xfrm>
            </p:grpSpPr>
            <p:pic>
              <p:nvPicPr>
                <p:cNvPr id="9" name="Picture 8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6353" r="54257" b="36995"/>
                <a:stretch/>
              </p:blipFill>
              <p:spPr bwMode="auto">
                <a:xfrm>
                  <a:off x="270090" y="1936961"/>
                  <a:ext cx="4125046" cy="120167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1116233" y="1554481"/>
                  <a:ext cx="51073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3276599" y="1563445"/>
                  <a:ext cx="5334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pic>
        <p:nvPicPr>
          <p:cNvPr id="24" name="Picture 2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700" t="37114" b="37915"/>
          <a:stretch/>
        </p:blipFill>
        <p:spPr bwMode="auto">
          <a:xfrm>
            <a:off x="5022011" y="152400"/>
            <a:ext cx="1828800" cy="24552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281625" y="7811219"/>
            <a:ext cx="62715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xplots of the 10 multi-spectral traits assessed in rice seed of 197 of the Philippine pigmented rice accessions. The boxplots show quantitative trait variation of the accessions from different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roups (mixed, white, red, purple and variable purple).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roups are visually defined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82577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228600"/>
            <a:ext cx="6492240" cy="360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34112" y="4201180"/>
            <a:ext cx="66690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istogra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the distribu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geometrics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related parameters in the 197 Philippine pigmented rice accessions screened using multi-spectral imaging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62080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64" y="380999"/>
            <a:ext cx="6696636" cy="60269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91440" y="6629400"/>
            <a:ext cx="6705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1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-spectral traits assessed in ric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19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ilippine pigmented ric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. The intensity of the blue (positive correlation) and red (negative correlation)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fines the strength of the correlation coefficient (i.e. the deeper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greater the correlation). Insignificant correlations are not included in this figur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15985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10" y="381000"/>
            <a:ext cx="6551997" cy="39311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7802" y="4306669"/>
            <a:ext cx="65128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5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samp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by region among the 696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ilippine pigmented rice accessions. X-axis = the administrative regions of the Philippines where the samples were collected. Y-axis = the number of samples collected in each reg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5759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3810948"/>
            <a:ext cx="6781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 of IBD PI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imates of the 589 Philippine pigmented rice accessions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defined based on the estimated probability of identity. A substantial proportion of the samples were genetically identical (estimate PI = 1, orange color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4802" y="8983563"/>
            <a:ext cx="64065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 of IBD PI estimates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the 307 unique accessions retained for downstream analys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defined based on the estimated probability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ty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1" y="0"/>
            <a:ext cx="5867399" cy="38770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5" y="4563963"/>
            <a:ext cx="6682821" cy="441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80191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838200"/>
            <a:ext cx="6766560" cy="6766560"/>
            <a:chOff x="1143000" y="10886"/>
            <a:chExt cx="6617762" cy="673169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5" t="5389" r="6391" b="5765"/>
            <a:stretch/>
          </p:blipFill>
          <p:spPr bwMode="auto">
            <a:xfrm>
              <a:off x="1143000" y="10886"/>
              <a:ext cx="6617762" cy="67316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994681" y="3046040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95600" y="2922930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72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5400000">
              <a:off x="2536371" y="3178622"/>
              <a:ext cx="4572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00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3950133">
              <a:off x="2702096" y="4390298"/>
              <a:ext cx="4572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9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079397">
              <a:off x="4665797" y="1659801"/>
              <a:ext cx="424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07467" y="3198440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38134" y="3063662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67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809777">
              <a:off x="5156023" y="1629490"/>
              <a:ext cx="424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98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4165920">
              <a:off x="5575553" y="2720243"/>
              <a:ext cx="4572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8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848290" y="3322306"/>
              <a:ext cx="3190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0</a:t>
              </a:r>
            </a:p>
          </p:txBody>
        </p:sp>
      </p:grpSp>
      <p:sp>
        <p:nvSpPr>
          <p:cNvPr id="14" name="Rectangle 13"/>
          <p:cNvSpPr/>
          <p:nvPr/>
        </p:nvSpPr>
        <p:spPr>
          <a:xfrm>
            <a:off x="104052" y="8196630"/>
            <a:ext cx="663047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ighbou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join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e show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hylogenetic relationships between the 307 Philippine pigmented rice accessions. The 307 accessions are divided into two main cluste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ypes, with few accessions reported as admix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83785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86447" y="5525869"/>
            <a:ext cx="6553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7 selec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ilippi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gmented rice accessions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ding is  based on region of origin. No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aliz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geographic origin is observed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949" y="685800"/>
            <a:ext cx="6582697" cy="47019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55672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oup 92"/>
          <p:cNvGrpSpPr/>
          <p:nvPr/>
        </p:nvGrpSpPr>
        <p:grpSpPr>
          <a:xfrm>
            <a:off x="154675" y="5943600"/>
            <a:ext cx="6398526" cy="1559692"/>
            <a:chOff x="-152400" y="3593915"/>
            <a:chExt cx="7060319" cy="1559692"/>
          </a:xfrm>
        </p:grpSpPr>
        <p:grpSp>
          <p:nvGrpSpPr>
            <p:cNvPr id="54" name="Group 53"/>
            <p:cNvGrpSpPr/>
            <p:nvPr/>
          </p:nvGrpSpPr>
          <p:grpSpPr>
            <a:xfrm>
              <a:off x="422805" y="3593915"/>
              <a:ext cx="6485114" cy="1530745"/>
              <a:chOff x="860231" y="3593915"/>
              <a:chExt cx="6485114" cy="1530745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68" t="11935" r="5494" b="42361"/>
              <a:stretch/>
            </p:blipFill>
            <p:spPr bwMode="auto">
              <a:xfrm>
                <a:off x="860231" y="3870916"/>
                <a:ext cx="6485114" cy="12537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" name="Left Bracket 11"/>
              <p:cNvSpPr/>
              <p:nvPr/>
            </p:nvSpPr>
            <p:spPr>
              <a:xfrm rot="5400000">
                <a:off x="1024450" y="3710338"/>
                <a:ext cx="190500" cy="511652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Left Bracket 24"/>
              <p:cNvSpPr/>
              <p:nvPr/>
            </p:nvSpPr>
            <p:spPr>
              <a:xfrm rot="5400000">
                <a:off x="2647950" y="3508966"/>
                <a:ext cx="190500" cy="9144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Left Bracket 25"/>
              <p:cNvSpPr/>
              <p:nvPr/>
            </p:nvSpPr>
            <p:spPr>
              <a:xfrm rot="5400000">
                <a:off x="1762228" y="3480286"/>
                <a:ext cx="133143" cy="9144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Left Bracket 26"/>
              <p:cNvSpPr/>
              <p:nvPr/>
            </p:nvSpPr>
            <p:spPr>
              <a:xfrm rot="5400000">
                <a:off x="5915128" y="2680189"/>
                <a:ext cx="133143" cy="25146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Left Bracket 27"/>
              <p:cNvSpPr/>
              <p:nvPr/>
            </p:nvSpPr>
            <p:spPr>
              <a:xfrm rot="5400000">
                <a:off x="4186288" y="3494629"/>
                <a:ext cx="161823" cy="9144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Left Bracket 28"/>
              <p:cNvSpPr/>
              <p:nvPr/>
            </p:nvSpPr>
            <p:spPr>
              <a:xfrm rot="5400000">
                <a:off x="3424288" y="3647027"/>
                <a:ext cx="161823" cy="6096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910150" y="3601201"/>
                <a:ext cx="41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629596" y="3601201"/>
                <a:ext cx="41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cs typeface="Times New Roman" panose="02020603050405020304" pitchFamily="18" charset="0"/>
                  </a:rPr>
                  <a:t>II</a:t>
                </a:r>
                <a:endParaRPr lang="en-US" sz="10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533649" y="3608490"/>
                <a:ext cx="41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cs typeface="Times New Roman" panose="02020603050405020304" pitchFamily="18" charset="0"/>
                  </a:rPr>
                  <a:t>III</a:t>
                </a:r>
                <a:endParaRPr lang="en-US" sz="10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295649" y="3625828"/>
                <a:ext cx="41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cs typeface="Times New Roman" panose="02020603050405020304" pitchFamily="18" charset="0"/>
                  </a:rPr>
                  <a:t>IV</a:t>
                </a:r>
                <a:endParaRPr lang="en-US" sz="10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097856" y="3601200"/>
                <a:ext cx="41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cs typeface="Times New Roman" panose="02020603050405020304" pitchFamily="18" charset="0"/>
                  </a:rPr>
                  <a:t>V</a:t>
                </a:r>
                <a:endParaRPr lang="en-US" sz="10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514974" y="3593915"/>
                <a:ext cx="9334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cs typeface="Times New Roman" panose="02020603050405020304" pitchFamily="18" charset="0"/>
                  </a:rPr>
                  <a:t>Others</a:t>
                </a:r>
                <a:endParaRPr lang="en-US" sz="1000" b="1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9" name="Group 88"/>
            <p:cNvGrpSpPr/>
            <p:nvPr/>
          </p:nvGrpSpPr>
          <p:grpSpPr>
            <a:xfrm>
              <a:off x="-152400" y="3872049"/>
              <a:ext cx="422630" cy="1281558"/>
              <a:chOff x="3119110" y="5922709"/>
              <a:chExt cx="422630" cy="1281558"/>
            </a:xfrm>
          </p:grpSpPr>
          <p:cxnSp>
            <p:nvCxnSpPr>
              <p:cNvPr id="74" name="Straight Connector 73"/>
              <p:cNvCxnSpPr/>
              <p:nvPr/>
            </p:nvCxnSpPr>
            <p:spPr>
              <a:xfrm>
                <a:off x="3533177" y="6045820"/>
                <a:ext cx="0" cy="105156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3399962" y="6045820"/>
                <a:ext cx="1371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/>
              <p:cNvSpPr txBox="1"/>
              <p:nvPr/>
            </p:nvSpPr>
            <p:spPr>
              <a:xfrm>
                <a:off x="3186468" y="5922709"/>
                <a:ext cx="2095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cs typeface="Times New Roman" panose="02020603050405020304" pitchFamily="18" charset="0"/>
                  </a:rPr>
                  <a:t>0</a:t>
                </a:r>
                <a:endParaRPr lang="en-US" sz="1000" dirty="0"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7" name="Straight Connector 86"/>
              <p:cNvCxnSpPr/>
              <p:nvPr/>
            </p:nvCxnSpPr>
            <p:spPr>
              <a:xfrm>
                <a:off x="3404580" y="6571600"/>
                <a:ext cx="1371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3396017" y="7097380"/>
                <a:ext cx="1371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3119110" y="6435888"/>
                <a:ext cx="4104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cs typeface="Times New Roman" panose="02020603050405020304" pitchFamily="18" charset="0"/>
                  </a:rPr>
                  <a:t>0.5</a:t>
                </a:r>
                <a:endParaRPr lang="en-US" sz="1000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3172547" y="6958046"/>
                <a:ext cx="2095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cs typeface="Times New Roman" panose="02020603050405020304" pitchFamily="18" charset="0"/>
                  </a:rPr>
                  <a:t>1</a:t>
                </a:r>
                <a:endParaRPr lang="en-US" sz="1000" dirty="0"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92" name="Rectangle 91"/>
          <p:cNvSpPr/>
          <p:nvPr/>
        </p:nvSpPr>
        <p:spPr>
          <a:xfrm>
            <a:off x="86307" y="8153400"/>
            <a:ext cx="670605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 the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ice accessions from the co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ilippine pigmen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collec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ross-validation plot. Cross-validation error is on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-ax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number of hypothetical populations is on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-axi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sults at K = 5 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. Individu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cestry inferred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MIXTUR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individual is represented by a vertical line partition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roportion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king up each vertical line represents the proportion contributed by the ancestral popul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are divided into V subgroups (I to V)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a membership probability lower than 0.8 was considered admix and classified 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hers. </a:t>
            </a:r>
            <a:endParaRPr lang="en-US" sz="1200" dirty="0"/>
          </a:p>
        </p:txBody>
      </p:sp>
      <p:pic>
        <p:nvPicPr>
          <p:cNvPr id="9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54" t="10000" r="12757" b="8073"/>
          <a:stretch/>
        </p:blipFill>
        <p:spPr bwMode="auto">
          <a:xfrm>
            <a:off x="683287" y="762000"/>
            <a:ext cx="5503209" cy="36391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4" name="TextBox 93"/>
          <p:cNvSpPr txBox="1"/>
          <p:nvPr/>
        </p:nvSpPr>
        <p:spPr>
          <a:xfrm>
            <a:off x="154674" y="304800"/>
            <a:ext cx="302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7" name="TextBox 96"/>
          <p:cNvSpPr txBox="1"/>
          <p:nvPr/>
        </p:nvSpPr>
        <p:spPr>
          <a:xfrm>
            <a:off x="126455" y="5486400"/>
            <a:ext cx="3025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8" name="TextBox 97"/>
          <p:cNvSpPr txBox="1"/>
          <p:nvPr/>
        </p:nvSpPr>
        <p:spPr>
          <a:xfrm rot="16200000">
            <a:off x="-206605" y="2362280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Cross validation error</a:t>
            </a:r>
            <a:endParaRPr lang="en-US" sz="10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3304086" y="4462323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K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201359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22" t="9887" r="12927" b="8812"/>
          <a:stretch/>
        </p:blipFill>
        <p:spPr bwMode="auto">
          <a:xfrm>
            <a:off x="0" y="11723"/>
            <a:ext cx="6049516" cy="3954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64" name="Group 2063"/>
          <p:cNvGrpSpPr/>
          <p:nvPr/>
        </p:nvGrpSpPr>
        <p:grpSpPr>
          <a:xfrm>
            <a:off x="61052" y="5379370"/>
            <a:ext cx="6659450" cy="1556158"/>
            <a:chOff x="-83137" y="6597148"/>
            <a:chExt cx="6941137" cy="1556158"/>
          </a:xfrm>
        </p:grpSpPr>
        <p:grpSp>
          <p:nvGrpSpPr>
            <p:cNvPr id="2063" name="Group 2062"/>
            <p:cNvGrpSpPr/>
            <p:nvPr/>
          </p:nvGrpSpPr>
          <p:grpSpPr>
            <a:xfrm>
              <a:off x="-83137" y="6597148"/>
              <a:ext cx="6941137" cy="1556158"/>
              <a:chOff x="-83137" y="6597148"/>
              <a:chExt cx="6941137" cy="1556158"/>
            </a:xfrm>
          </p:grpSpPr>
          <p:grpSp>
            <p:nvGrpSpPr>
              <p:cNvPr id="31" name="Group 30"/>
              <p:cNvGrpSpPr/>
              <p:nvPr/>
            </p:nvGrpSpPr>
            <p:grpSpPr>
              <a:xfrm>
                <a:off x="453266" y="6597148"/>
                <a:ext cx="6404734" cy="1433049"/>
                <a:chOff x="453266" y="6597148"/>
                <a:chExt cx="6404734" cy="1433049"/>
              </a:xfrm>
            </p:grpSpPr>
            <p:pic>
              <p:nvPicPr>
                <p:cNvPr id="2050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615" t="21128" r="7692" b="35748"/>
                <a:stretch/>
              </p:blipFill>
              <p:spPr bwMode="auto">
                <a:xfrm>
                  <a:off x="463291" y="6945812"/>
                  <a:ext cx="6394709" cy="108438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22" name="Group 21"/>
                <p:cNvGrpSpPr/>
                <p:nvPr/>
              </p:nvGrpSpPr>
              <p:grpSpPr>
                <a:xfrm>
                  <a:off x="453266" y="6597148"/>
                  <a:ext cx="6404734" cy="374622"/>
                  <a:chOff x="453266" y="6597148"/>
                  <a:chExt cx="6404734" cy="374622"/>
                </a:xfrm>
              </p:grpSpPr>
              <p:sp>
                <p:nvSpPr>
                  <p:cNvPr id="13" name="Left Bracket 12"/>
                  <p:cNvSpPr/>
                  <p:nvPr/>
                </p:nvSpPr>
                <p:spPr>
                  <a:xfrm rot="5400000">
                    <a:off x="2047107" y="6711961"/>
                    <a:ext cx="106299" cy="390514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" name="Left Bracket 13"/>
                  <p:cNvSpPr/>
                  <p:nvPr/>
                </p:nvSpPr>
                <p:spPr>
                  <a:xfrm rot="5400000">
                    <a:off x="1574893" y="6620212"/>
                    <a:ext cx="87458" cy="555172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" name="Left Bracket 14"/>
                  <p:cNvSpPr/>
                  <p:nvPr/>
                </p:nvSpPr>
                <p:spPr>
                  <a:xfrm rot="5400000">
                    <a:off x="5028831" y="5075171"/>
                    <a:ext cx="50272" cy="3608066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" name="Left Bracket 15"/>
                  <p:cNvSpPr/>
                  <p:nvPr/>
                </p:nvSpPr>
                <p:spPr>
                  <a:xfrm rot="5400000">
                    <a:off x="1106189" y="6732848"/>
                    <a:ext cx="113626" cy="356068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" name="Left Bracket 16"/>
                  <p:cNvSpPr/>
                  <p:nvPr/>
                </p:nvSpPr>
                <p:spPr>
                  <a:xfrm rot="5400000">
                    <a:off x="554628" y="6773781"/>
                    <a:ext cx="73152" cy="255826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8" name="Left Bracket 17"/>
                  <p:cNvSpPr/>
                  <p:nvPr/>
                </p:nvSpPr>
                <p:spPr>
                  <a:xfrm rot="5400000">
                    <a:off x="2449635" y="6699949"/>
                    <a:ext cx="117700" cy="425941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" name="Left Bracket 18"/>
                  <p:cNvSpPr/>
                  <p:nvPr/>
                </p:nvSpPr>
                <p:spPr>
                  <a:xfrm rot="5400000">
                    <a:off x="2924132" y="6651392"/>
                    <a:ext cx="106300" cy="511652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" name="Left Bracket 19"/>
                  <p:cNvSpPr/>
                  <p:nvPr/>
                </p:nvSpPr>
                <p:spPr>
                  <a:xfrm rot="5400000">
                    <a:off x="806784" y="6776427"/>
                    <a:ext cx="100542" cy="255826"/>
                  </a:xfrm>
                  <a:prstGeom prst="leftBracket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453266" y="6640469"/>
                    <a:ext cx="26585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I</a:t>
                    </a:r>
                    <a:endParaRPr lang="en-US" sz="1000" b="1" dirty="0"/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729142" y="6632983"/>
                    <a:ext cx="26251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II</a:t>
                    </a:r>
                    <a:endParaRPr lang="en-US" sz="1000" b="1" dirty="0"/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1010602" y="6651577"/>
                    <a:ext cx="3048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III</a:t>
                    </a:r>
                    <a:endParaRPr lang="en-US" sz="1000" b="1" dirty="0"/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1468734" y="6641540"/>
                    <a:ext cx="30480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IV</a:t>
                    </a:r>
                    <a:endParaRPr lang="en-US" sz="1000" b="1" dirty="0"/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1959729" y="6641539"/>
                    <a:ext cx="262513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V</a:t>
                    </a:r>
                    <a:endParaRPr lang="en-US" sz="1000" b="1" dirty="0"/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2353490" y="6632551"/>
                    <a:ext cx="30998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VI</a:t>
                    </a:r>
                    <a:endParaRPr lang="en-US" sz="1000" b="1" dirty="0"/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2793647" y="6644993"/>
                    <a:ext cx="36727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VII</a:t>
                    </a:r>
                    <a:endParaRPr lang="en-US" sz="1000" b="1" dirty="0"/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4648200" y="6597148"/>
                    <a:ext cx="631344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smtClean="0"/>
                      <a:t>Others</a:t>
                    </a:r>
                    <a:endParaRPr lang="en-US" sz="1000" b="1" dirty="0"/>
                  </a:p>
                </p:txBody>
              </p:sp>
            </p:grpSp>
          </p:grpSp>
          <p:grpSp>
            <p:nvGrpSpPr>
              <p:cNvPr id="2062" name="Group 2061"/>
              <p:cNvGrpSpPr/>
              <p:nvPr/>
            </p:nvGrpSpPr>
            <p:grpSpPr>
              <a:xfrm>
                <a:off x="-83137" y="6960368"/>
                <a:ext cx="486718" cy="1192938"/>
                <a:chOff x="-83137" y="6960368"/>
                <a:chExt cx="486718" cy="1192938"/>
              </a:xfrm>
            </p:grpSpPr>
            <p:cxnSp>
              <p:nvCxnSpPr>
                <p:cNvPr id="2049" name="Straight Connector 2048"/>
                <p:cNvCxnSpPr/>
                <p:nvPr/>
              </p:nvCxnSpPr>
              <p:spPr>
                <a:xfrm>
                  <a:off x="308149" y="6960368"/>
                  <a:ext cx="0" cy="106982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7" name="Straight Connector 2056"/>
                <p:cNvCxnSpPr/>
                <p:nvPr/>
              </p:nvCxnSpPr>
              <p:spPr>
                <a:xfrm>
                  <a:off x="228600" y="6960368"/>
                  <a:ext cx="7954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>
                  <a:off x="217295" y="7495282"/>
                  <a:ext cx="7954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188825" y="8030197"/>
                  <a:ext cx="119324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61" name="TextBox 2060"/>
                <p:cNvSpPr txBox="1"/>
                <p:nvPr/>
              </p:nvSpPr>
              <p:spPr>
                <a:xfrm>
                  <a:off x="0" y="7907085"/>
                  <a:ext cx="18882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/>
                    <a:t>0</a:t>
                  </a:r>
                  <a:endParaRPr lang="en-US" sz="1000" dirty="0"/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-83137" y="7372171"/>
                  <a:ext cx="48671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/>
                    <a:t>0.5</a:t>
                  </a:r>
                  <a:endParaRPr lang="en-US" sz="1000" dirty="0"/>
                </a:p>
              </p:txBody>
            </p:sp>
          </p:grpSp>
        </p:grpSp>
        <p:sp>
          <p:nvSpPr>
            <p:cNvPr id="50" name="TextBox 49"/>
            <p:cNvSpPr txBox="1"/>
            <p:nvPr/>
          </p:nvSpPr>
          <p:spPr>
            <a:xfrm>
              <a:off x="49914" y="6843369"/>
              <a:ext cx="1888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</a:t>
              </a:r>
              <a:endParaRPr lang="en-US" sz="1000" dirty="0"/>
            </a:p>
          </p:txBody>
        </p:sp>
      </p:grpSp>
      <p:sp>
        <p:nvSpPr>
          <p:cNvPr id="54" name="Rectangle 53"/>
          <p:cNvSpPr/>
          <p:nvPr/>
        </p:nvSpPr>
        <p:spPr>
          <a:xfrm>
            <a:off x="61052" y="7848600"/>
            <a:ext cx="670605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withi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ponic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accessions of the co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ilippine pigmen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28600" indent="-228600" algn="just">
              <a:buFontTx/>
              <a:buAutoNum type="alphaLcParenBoth"/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within th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e accessions from the core Philippine pigmented rice collection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ross-validation plot. Cross-validation error is on the Y-axis and the number of hypothetical populations is on the X-axi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sults at K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shown. Individual ancestry inferred with ADMIXTURE. Each individual is represented by a vertical line partition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roportion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king up each vertical line represents the proportion contributed by the ancestral population. The rice accessions are divided in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groups (I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 with a membership probability lower than 0.8 was considered admix and classified as others. </a:t>
            </a:r>
            <a:endParaRPr lang="en-US" sz="1200" dirty="0"/>
          </a:p>
          <a:p>
            <a:pPr marL="228600" indent="-228600" algn="just">
              <a:buAutoNum type="alphaLcParenBoth"/>
            </a:pP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948904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533400"/>
            <a:ext cx="6690852" cy="47791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137652" y="5562600"/>
            <a:ext cx="6705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analysis of 307 core Philippine pigmented rice accessions. The additive relationship matrix was calculated for the 307 core Philippine pigmented rice accession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BLU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R packag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rBLU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elm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011) and used as input to the PCA. The pigmentation of the pericarp was observed in bo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s.</a:t>
            </a:r>
          </a:p>
        </p:txBody>
      </p:sp>
    </p:spTree>
    <p:extLst>
      <p:ext uri="{BB962C8B-B14F-4D97-AF65-F5344CB8AC3E}">
        <p14:creationId xmlns:p14="http://schemas.microsoft.com/office/powerpoint/2010/main" val="14227360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" y="4705516"/>
            <a:ext cx="6477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level of heterozygosity in individual rice accessions making-up the 307 core collection. X-axis = rice access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Y-axis = heterozygosity rate. Low levels of heterozygosity were observed in most rice accession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79" y="295275"/>
            <a:ext cx="6574396" cy="42109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34366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jignacio\Downloads\heatmap_polymorphic_snps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37" r="13387"/>
          <a:stretch/>
        </p:blipFill>
        <p:spPr bwMode="auto">
          <a:xfrm>
            <a:off x="285749" y="609600"/>
            <a:ext cx="5962651" cy="5133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6200" y="5994737"/>
            <a:ext cx="5943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NP markers between the 307 Philippine pigmented ric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. This figure shows how many SNPs out of the selected 20 SNPs are polymorphic between the 307 accessions. Each row and column represents an accession, and eac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ur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 shows the corresponding number of polymorphic SNPs between any two accessions.  The blue diagonal indicates no polymorphism between a pairwise comparison of the same accession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150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32</TotalTime>
  <Words>851</Words>
  <Application>Microsoft Office PowerPoint</Application>
  <PresentationFormat>A4 Paper (210x297 mm)</PresentationFormat>
  <Paragraphs>60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kouaya Mbanjo, Edwige Gaby (IRRI)</dc:creator>
  <cp:lastModifiedBy>Nkouaya Mbanjo, Edwige Gaby (IRRI)</cp:lastModifiedBy>
  <cp:revision>130</cp:revision>
  <dcterms:created xsi:type="dcterms:W3CDTF">2006-08-16T00:00:00Z</dcterms:created>
  <dcterms:modified xsi:type="dcterms:W3CDTF">2019-03-13T12:20:35Z</dcterms:modified>
</cp:coreProperties>
</file>